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9916426-6AA7-E92C-DE91-00F7F4AAC5E7}" name="Nichols, Tracy - MRP-APHIS" initials="TN" userId="S::tracy.a.nichols@usda.gov::7f2557b3-7a5e-4c31-a5a9-359a22031f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2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1459F-BADD-45BE-8004-1673DE87BE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E4E02A-B208-4E15-A43B-5883EF4E4D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EFEC7-0D57-4F90-8A7E-C59016F0D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BC876D-45B1-4AB3-8CFE-CE4FD30EC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D6AF7E-4E87-4161-B2C1-DC3623D17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071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29755-35DC-4749-B49C-AB7377C44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3A426F-DC0E-4B15-A51D-02443C3376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5C5EA1-7E07-4E10-B300-874D0EC2F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75FCFC-45EB-4F96-BBFE-7041C7C4F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623823-B615-4E6D-85CE-A9F36E669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56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DDB739-4F1C-4CF8-B4FF-CB82D7D35A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E5C569-9F93-49D2-BF3F-34E33BF2F4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208D0-8C10-4AC2-BE08-157A9C0A1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178BE3-993C-4691-864E-0B137248F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4B31-1EC4-4123-9B8F-E7476B0B4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004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FDA2D4-DB60-4B49-95BC-FF2237284E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C48F5E-77A3-4DC7-9B88-F993E5B0C7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1DFA13-63E1-4FF5-92FE-198C0E863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8E9A6B-C62F-48E4-A111-311057F3B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3DA35-4011-4149-AA7B-C26393F56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458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F75E6D-E805-44BA-8B16-1EB4B0148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EC9DA3-6A0F-47B6-B12E-E71B2CA38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E00008-BF66-4156-93D3-319C58B35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889D1E-8E78-4146-8E55-5F638622A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D9091-981B-4DB6-976B-BACA68572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504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F7E827-E89C-4CDA-BB42-3BED42546D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1A4F6D-600C-4291-A0EB-E10BB86AA3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24E800-0B7F-424E-8B0D-91F437CCD7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D96232-BFFC-431E-8566-0E1ED1EBB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C706F8-CC16-45FB-B1B4-BCE819174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C88761-099D-4DCB-AAF9-950F3C441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292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81107-1EE8-4D07-AD6B-36A841EB6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90CAFC-8976-483E-96CF-88882A7DE3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2F2BCF-E34B-43C7-8BB1-0A36B2F4B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56601B-DD59-44F2-9C78-F322B60BFF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B5F9C3-CD07-4D75-B5E1-8BC6618D81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9E57D6-BA24-4CB6-80B7-68BBFA6A4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9C0480-AB2A-448A-B600-275AA8610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17C0B5-92B7-4CB9-AF18-B73690B5F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946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A7752-2C06-42E9-A99A-5F560DD42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D61DA0-E966-4FB8-AC4C-74E43A5EA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872537-95DD-4015-8843-499E7F215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576294-436E-44DB-A21C-7C6281960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272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053D3E-8146-425D-AE11-BE7D517DA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90B6B3-5AFF-4FEA-82EC-4CE09576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25FA20-FC55-40B9-ACFE-26BB4755D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300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AECC4-715F-4463-B483-4E10DB239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CF9ECE-6F3F-43DB-9C07-EC05AEB646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85DB54-C030-4527-8CDB-A9223261F0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3E5247-1B34-4373-9AD2-165F9567D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B27E6A-7061-407E-ACD8-668E6162E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6AFC1B-8E59-457B-9C9F-70FAB714F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591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54D4F6-DBF8-499C-B098-E95D77180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760AF2-E68B-4580-9760-93E86075F2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5A0910-E7F1-4F0B-AB1C-2AB9BA43F2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38BC99-EE74-4CAE-B1F3-246E250CD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E2BA91-1808-4FCE-BE5E-6CB97C9F6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722113-CF79-4F4E-915B-BFAD5B6B2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62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9394DB-C158-47A6-9C2A-9AFC67178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6E5448-76A7-476C-A5A3-6A1FE7F656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0F9AB-1BCC-4035-836F-6A72FF00D7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800870-8DCB-478B-952A-F2A65C538285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5FD21-302B-488F-80EE-7009E6C955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35C84-8E0C-420B-A907-2B3EFAE79E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85194-0F10-4031-94A8-70FEC85ED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21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>
            <a:extLst>
              <a:ext uri="{FF2B5EF4-FFF2-40B4-BE49-F238E27FC236}">
                <a16:creationId xmlns:a16="http://schemas.microsoft.com/office/drawing/2014/main" id="{5BDDCC86-C7B8-471F-BDDD-B023354652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575" t="12140" r="59541" b="74294"/>
          <a:stretch/>
        </p:blipFill>
        <p:spPr>
          <a:xfrm>
            <a:off x="2904336" y="2010833"/>
            <a:ext cx="2711075" cy="9844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954C49E-25C1-41C5-B252-9A83CD7793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478" t="28683" r="59638" b="57751"/>
          <a:stretch/>
        </p:blipFill>
        <p:spPr>
          <a:xfrm>
            <a:off x="1715438" y="4813086"/>
            <a:ext cx="2788953" cy="9844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A047CC6-28FC-4D0D-99F9-C55D0F8D6876}"/>
              </a:ext>
            </a:extLst>
          </p:cNvPr>
          <p:cNvSpPr txBox="1"/>
          <p:nvPr/>
        </p:nvSpPr>
        <p:spPr>
          <a:xfrm rot="17841062">
            <a:off x="1585377" y="4314742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plee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0D60B54-484B-455C-9F84-F9AE9346E6FD}"/>
              </a:ext>
            </a:extLst>
          </p:cNvPr>
          <p:cNvSpPr txBox="1"/>
          <p:nvPr/>
        </p:nvSpPr>
        <p:spPr>
          <a:xfrm rot="17841062">
            <a:off x="1821992" y="4335496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Rectum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00E88A8-FCBF-435B-B9A6-2EB5B55EDDED}"/>
              </a:ext>
            </a:extLst>
          </p:cNvPr>
          <p:cNvSpPr txBox="1"/>
          <p:nvPr/>
        </p:nvSpPr>
        <p:spPr>
          <a:xfrm rot="17841062">
            <a:off x="1832412" y="3935714"/>
            <a:ext cx="150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ntestin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715B4D6-8754-497F-885A-16FDB6CCFE00}"/>
              </a:ext>
            </a:extLst>
          </p:cNvPr>
          <p:cNvSpPr txBox="1"/>
          <p:nvPr/>
        </p:nvSpPr>
        <p:spPr>
          <a:xfrm rot="17841062">
            <a:off x="2486410" y="4301277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ear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09E2C9B-10F9-438B-90FB-0FE6B4E4C6F6}"/>
              </a:ext>
            </a:extLst>
          </p:cNvPr>
          <p:cNvSpPr txBox="1"/>
          <p:nvPr/>
        </p:nvSpPr>
        <p:spPr>
          <a:xfrm rot="17841062">
            <a:off x="2718641" y="4288300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ung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26CB5DB-636C-4090-8923-321F7B2F8A9C}"/>
              </a:ext>
            </a:extLst>
          </p:cNvPr>
          <p:cNvSpPr txBox="1"/>
          <p:nvPr/>
        </p:nvSpPr>
        <p:spPr>
          <a:xfrm rot="17841062">
            <a:off x="2775733" y="3971976"/>
            <a:ext cx="138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ive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6723EFC-1BD5-4348-97A5-CEA388A4E4FC}"/>
              </a:ext>
            </a:extLst>
          </p:cNvPr>
          <p:cNvSpPr txBox="1"/>
          <p:nvPr/>
        </p:nvSpPr>
        <p:spPr>
          <a:xfrm rot="17841062">
            <a:off x="3449236" y="4278967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Cecum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AC866EB-6726-4EE6-B25D-F999E256B87C}"/>
              </a:ext>
            </a:extLst>
          </p:cNvPr>
          <p:cNvSpPr txBox="1"/>
          <p:nvPr/>
        </p:nvSpPr>
        <p:spPr>
          <a:xfrm rot="17841062">
            <a:off x="3587604" y="4118443"/>
            <a:ext cx="1059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Medial LN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E904EF-D268-4B98-A1F3-D6D7B8ECC878}"/>
              </a:ext>
            </a:extLst>
          </p:cNvPr>
          <p:cNvSpPr txBox="1"/>
          <p:nvPr/>
        </p:nvSpPr>
        <p:spPr>
          <a:xfrm rot="17841062">
            <a:off x="5636310" y="4038351"/>
            <a:ext cx="12805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e-scapular L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31EA5A8-4B7F-4899-8097-5BC2877BC4D6}"/>
              </a:ext>
            </a:extLst>
          </p:cNvPr>
          <p:cNvSpPr txBox="1"/>
          <p:nvPr/>
        </p:nvSpPr>
        <p:spPr>
          <a:xfrm rot="17841062">
            <a:off x="5809196" y="3935714"/>
            <a:ext cx="1481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opliteal L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57E216C-6613-4F96-B0D1-81DCE8270066}"/>
              </a:ext>
            </a:extLst>
          </p:cNvPr>
          <p:cNvSpPr txBox="1"/>
          <p:nvPr/>
        </p:nvSpPr>
        <p:spPr>
          <a:xfrm rot="17841062">
            <a:off x="6125410" y="4067060"/>
            <a:ext cx="1215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esenteric L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542F850-6B61-4964-AB21-5BF930EBDBAD}"/>
              </a:ext>
            </a:extLst>
          </p:cNvPr>
          <p:cNvSpPr txBox="1"/>
          <p:nvPr/>
        </p:nvSpPr>
        <p:spPr>
          <a:xfrm rot="17841062">
            <a:off x="6356559" y="4030932"/>
            <a:ext cx="1276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ronchial L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AC6272F-A347-4084-9C1F-269C51CF0A87}"/>
              </a:ext>
            </a:extLst>
          </p:cNvPr>
          <p:cNvSpPr txBox="1"/>
          <p:nvPr/>
        </p:nvSpPr>
        <p:spPr>
          <a:xfrm rot="17841062">
            <a:off x="6565746" y="3918041"/>
            <a:ext cx="150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onsi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172BA92-AEB4-433A-98A0-22E975C57F70}"/>
              </a:ext>
            </a:extLst>
          </p:cNvPr>
          <p:cNvSpPr txBox="1"/>
          <p:nvPr/>
        </p:nvSpPr>
        <p:spPr>
          <a:xfrm rot="17841062">
            <a:off x="6829788" y="3995116"/>
            <a:ext cx="1325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bmandibular L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E5C3149-D93F-4ECA-87BC-18F4C5603B8A}"/>
              </a:ext>
            </a:extLst>
          </p:cNvPr>
          <p:cNvSpPr txBox="1"/>
          <p:nvPr/>
        </p:nvSpPr>
        <p:spPr>
          <a:xfrm rot="17841062">
            <a:off x="6980237" y="3886793"/>
            <a:ext cx="1594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e-CWD Fece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8DB5714-386B-4C92-A6B3-E7F80244695C}"/>
              </a:ext>
            </a:extLst>
          </p:cNvPr>
          <p:cNvSpPr txBox="1"/>
          <p:nvPr/>
        </p:nvSpPr>
        <p:spPr>
          <a:xfrm rot="17841062">
            <a:off x="7311644" y="4000843"/>
            <a:ext cx="1337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Feces DPI 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6CAF8DD-2670-4977-8EEA-4668850CD17F}"/>
              </a:ext>
            </a:extLst>
          </p:cNvPr>
          <p:cNvSpPr txBox="1"/>
          <p:nvPr/>
        </p:nvSpPr>
        <p:spPr>
          <a:xfrm rot="17841062">
            <a:off x="7669161" y="4182693"/>
            <a:ext cx="962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Feces DPI 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DC4C17A-7B40-4DD7-B9C4-621602B65AAC}"/>
              </a:ext>
            </a:extLst>
          </p:cNvPr>
          <p:cNvSpPr txBox="1"/>
          <p:nvPr/>
        </p:nvSpPr>
        <p:spPr>
          <a:xfrm rot="17841062">
            <a:off x="7836466" y="4023590"/>
            <a:ext cx="1307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Feces DPI 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7E085F5-9234-45B3-9E1E-45893A0C8F03}"/>
              </a:ext>
            </a:extLst>
          </p:cNvPr>
          <p:cNvSpPr txBox="1"/>
          <p:nvPr/>
        </p:nvSpPr>
        <p:spPr>
          <a:xfrm rot="17841062">
            <a:off x="9817323" y="4011550"/>
            <a:ext cx="1348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Feces DPI 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42FFC2C-1D5F-4EEA-8794-58E585C77B23}"/>
              </a:ext>
            </a:extLst>
          </p:cNvPr>
          <p:cNvSpPr txBox="1"/>
          <p:nvPr/>
        </p:nvSpPr>
        <p:spPr>
          <a:xfrm rot="17841062">
            <a:off x="2273225" y="4295137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rai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44C93EB-1E02-4FBC-A0D0-0A3FEDC6FD68}"/>
              </a:ext>
            </a:extLst>
          </p:cNvPr>
          <p:cNvSpPr txBox="1"/>
          <p:nvPr/>
        </p:nvSpPr>
        <p:spPr>
          <a:xfrm rot="17841062">
            <a:off x="3219169" y="4278967"/>
            <a:ext cx="696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Kidney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C1C62F95-7B12-43A1-B4F5-3274F1EF5599}"/>
              </a:ext>
            </a:extLst>
          </p:cNvPr>
          <p:cNvCxnSpPr>
            <a:cxnSpLocks/>
          </p:cNvCxnSpPr>
          <p:nvPr/>
        </p:nvCxnSpPr>
        <p:spPr>
          <a:xfrm>
            <a:off x="4505742" y="5355612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65DFC43E-281A-45FE-96EC-1CEE8824E3B2}"/>
              </a:ext>
            </a:extLst>
          </p:cNvPr>
          <p:cNvCxnSpPr>
            <a:cxnSpLocks/>
          </p:cNvCxnSpPr>
          <p:nvPr/>
        </p:nvCxnSpPr>
        <p:spPr>
          <a:xfrm>
            <a:off x="4508137" y="5133610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DD970CE9-5749-4952-A2E2-CD93CDCEE2A3}"/>
              </a:ext>
            </a:extLst>
          </p:cNvPr>
          <p:cNvSpPr txBox="1"/>
          <p:nvPr/>
        </p:nvSpPr>
        <p:spPr>
          <a:xfrm>
            <a:off x="4603165" y="5019897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D3C161A-FFA4-49CA-BE0B-6BED8EA1C8A0}"/>
              </a:ext>
            </a:extLst>
          </p:cNvPr>
          <p:cNvSpPr txBox="1"/>
          <p:nvPr/>
        </p:nvSpPr>
        <p:spPr>
          <a:xfrm>
            <a:off x="4600770" y="5235341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kDa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7B3912DF-BA66-4383-9485-EEBA8BAD6E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680" t="49814" r="28436" b="36620"/>
          <a:stretch/>
        </p:blipFill>
        <p:spPr>
          <a:xfrm>
            <a:off x="5924539" y="4809040"/>
            <a:ext cx="2788953" cy="9844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325CDE5-7333-4ACD-8656-E6933BD7AD32}"/>
              </a:ext>
            </a:extLst>
          </p:cNvPr>
          <p:cNvCxnSpPr>
            <a:cxnSpLocks/>
          </p:cNvCxnSpPr>
          <p:nvPr/>
        </p:nvCxnSpPr>
        <p:spPr>
          <a:xfrm>
            <a:off x="8713492" y="5370935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2B548B7E-CCE1-491F-9106-AD990401920F}"/>
              </a:ext>
            </a:extLst>
          </p:cNvPr>
          <p:cNvCxnSpPr>
            <a:cxnSpLocks/>
          </p:cNvCxnSpPr>
          <p:nvPr/>
        </p:nvCxnSpPr>
        <p:spPr>
          <a:xfrm>
            <a:off x="8715887" y="5148933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8A1BD75A-A52C-4F16-9F04-98633B939139}"/>
              </a:ext>
            </a:extLst>
          </p:cNvPr>
          <p:cNvSpPr txBox="1"/>
          <p:nvPr/>
        </p:nvSpPr>
        <p:spPr>
          <a:xfrm>
            <a:off x="8810915" y="5035220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746CCAE-9DA5-4B70-899E-87B427DBCF3E}"/>
              </a:ext>
            </a:extLst>
          </p:cNvPr>
          <p:cNvSpPr txBox="1"/>
          <p:nvPr/>
        </p:nvSpPr>
        <p:spPr>
          <a:xfrm>
            <a:off x="8808520" y="5250664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kDa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2F51FB7E-11DE-4ABB-8DF1-4D019476137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074" t="64184" r="78964" b="22250"/>
          <a:stretch/>
        </p:blipFill>
        <p:spPr>
          <a:xfrm>
            <a:off x="10133640" y="4812633"/>
            <a:ext cx="668177" cy="9844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47C84909-89F5-4935-8C80-981E211663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68" t="63483" r="64086" b="22951"/>
          <a:stretch/>
        </p:blipFill>
        <p:spPr>
          <a:xfrm>
            <a:off x="6901413" y="1996984"/>
            <a:ext cx="1495774" cy="9844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B733A09C-8FD8-4C0B-B6EF-BE2A91BA08D4}"/>
              </a:ext>
            </a:extLst>
          </p:cNvPr>
          <p:cNvCxnSpPr>
            <a:cxnSpLocks/>
          </p:cNvCxnSpPr>
          <p:nvPr/>
        </p:nvCxnSpPr>
        <p:spPr>
          <a:xfrm>
            <a:off x="10829465" y="5355612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D2C7F8A-64E1-4FB3-AEFE-0726A3A0FBE2}"/>
              </a:ext>
            </a:extLst>
          </p:cNvPr>
          <p:cNvCxnSpPr>
            <a:cxnSpLocks/>
          </p:cNvCxnSpPr>
          <p:nvPr/>
        </p:nvCxnSpPr>
        <p:spPr>
          <a:xfrm>
            <a:off x="10831860" y="5133610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7DB1EF44-12FA-40C0-888F-A3165D5889DB}"/>
              </a:ext>
            </a:extLst>
          </p:cNvPr>
          <p:cNvSpPr txBox="1"/>
          <p:nvPr/>
        </p:nvSpPr>
        <p:spPr>
          <a:xfrm>
            <a:off x="10926888" y="5019897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3401166-644E-4D63-ABF7-97B7F514955B}"/>
              </a:ext>
            </a:extLst>
          </p:cNvPr>
          <p:cNvSpPr txBox="1"/>
          <p:nvPr/>
        </p:nvSpPr>
        <p:spPr>
          <a:xfrm>
            <a:off x="10924493" y="5235341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kD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9D7D514-5FE3-4B8E-AE87-B6CBA50D3653}"/>
              </a:ext>
            </a:extLst>
          </p:cNvPr>
          <p:cNvSpPr txBox="1"/>
          <p:nvPr/>
        </p:nvSpPr>
        <p:spPr>
          <a:xfrm>
            <a:off x="2836115" y="1725364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4</a:t>
            </a:r>
            <a:endParaRPr lang="en-US" sz="10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794043E-B360-41FA-8840-902044ACF950}"/>
              </a:ext>
            </a:extLst>
          </p:cNvPr>
          <p:cNvSpPr txBox="1"/>
          <p:nvPr/>
        </p:nvSpPr>
        <p:spPr>
          <a:xfrm>
            <a:off x="3459374" y="1421082"/>
            <a:ext cx="1723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WD Brain Dilution (-log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7BCDC7F-EAD7-4F06-9C86-8BE2DD8C9595}"/>
              </a:ext>
            </a:extLst>
          </p:cNvPr>
          <p:cNvSpPr txBox="1"/>
          <p:nvPr/>
        </p:nvSpPr>
        <p:spPr>
          <a:xfrm>
            <a:off x="3063401" y="1725364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5</a:t>
            </a:r>
            <a:endParaRPr lang="en-US" sz="10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5FF105F-F8FB-45CB-B079-69D975397075}"/>
              </a:ext>
            </a:extLst>
          </p:cNvPr>
          <p:cNvSpPr txBox="1"/>
          <p:nvPr/>
        </p:nvSpPr>
        <p:spPr>
          <a:xfrm>
            <a:off x="3285849" y="1725364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6</a:t>
            </a:r>
            <a:endParaRPr lang="en-US" sz="10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D424B6A-5E02-4503-AB60-C3D25486C760}"/>
              </a:ext>
            </a:extLst>
          </p:cNvPr>
          <p:cNvSpPr txBox="1"/>
          <p:nvPr/>
        </p:nvSpPr>
        <p:spPr>
          <a:xfrm>
            <a:off x="3494370" y="1725364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7</a:t>
            </a:r>
            <a:endParaRPr lang="en-US" sz="10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DB672E9-A417-411A-B358-1CDE07CC2EFD}"/>
              </a:ext>
            </a:extLst>
          </p:cNvPr>
          <p:cNvSpPr txBox="1"/>
          <p:nvPr/>
        </p:nvSpPr>
        <p:spPr>
          <a:xfrm>
            <a:off x="3713029" y="1727053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8</a:t>
            </a:r>
            <a:endParaRPr lang="en-US" sz="10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84C4BE9-B3E3-4A0C-B484-075857FFD28F}"/>
              </a:ext>
            </a:extLst>
          </p:cNvPr>
          <p:cNvSpPr txBox="1"/>
          <p:nvPr/>
        </p:nvSpPr>
        <p:spPr>
          <a:xfrm>
            <a:off x="3931688" y="1727052"/>
            <a:ext cx="384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9</a:t>
            </a:r>
            <a:endParaRPr lang="en-US" sz="10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80157E0-7814-417B-833C-01F58460F355}"/>
              </a:ext>
            </a:extLst>
          </p:cNvPr>
          <p:cNvSpPr txBox="1"/>
          <p:nvPr/>
        </p:nvSpPr>
        <p:spPr>
          <a:xfrm>
            <a:off x="4150347" y="1727051"/>
            <a:ext cx="45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10</a:t>
            </a:r>
            <a:endParaRPr lang="en-US" sz="10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790F181-3D03-4B70-8169-1312891538FB}"/>
              </a:ext>
            </a:extLst>
          </p:cNvPr>
          <p:cNvSpPr txBox="1"/>
          <p:nvPr/>
        </p:nvSpPr>
        <p:spPr>
          <a:xfrm>
            <a:off x="4397682" y="1725363"/>
            <a:ext cx="484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11</a:t>
            </a:r>
            <a:endParaRPr lang="en-US" sz="10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5FBB960-13E6-42F5-A1CE-E717206405B7}"/>
              </a:ext>
            </a:extLst>
          </p:cNvPr>
          <p:cNvSpPr txBox="1"/>
          <p:nvPr/>
        </p:nvSpPr>
        <p:spPr>
          <a:xfrm>
            <a:off x="4646863" y="1725631"/>
            <a:ext cx="4267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12</a:t>
            </a:r>
            <a:endParaRPr lang="en-US" sz="10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64F23BC-DFE7-478C-8D6A-046896FD01BC}"/>
              </a:ext>
            </a:extLst>
          </p:cNvPr>
          <p:cNvSpPr txBox="1"/>
          <p:nvPr/>
        </p:nvSpPr>
        <p:spPr>
          <a:xfrm>
            <a:off x="4893153" y="1729096"/>
            <a:ext cx="452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  <a:r>
              <a:rPr lang="en-US" sz="1000" baseline="30000" dirty="0"/>
              <a:t>-13</a:t>
            </a:r>
            <a:endParaRPr lang="en-US" sz="1000" dirty="0"/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21800AA7-CDC6-478C-B7E1-0599AEA991D6}"/>
              </a:ext>
            </a:extLst>
          </p:cNvPr>
          <p:cNvCxnSpPr>
            <a:cxnSpLocks/>
          </p:cNvCxnSpPr>
          <p:nvPr/>
        </p:nvCxnSpPr>
        <p:spPr>
          <a:xfrm>
            <a:off x="2914785" y="1663246"/>
            <a:ext cx="269769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7562D769-C227-4F82-9D45-688BB9A95371}"/>
              </a:ext>
            </a:extLst>
          </p:cNvPr>
          <p:cNvSpPr txBox="1"/>
          <p:nvPr/>
        </p:nvSpPr>
        <p:spPr>
          <a:xfrm>
            <a:off x="2529118" y="146524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)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CC934F4D-4580-41F5-AF8D-0F3ABC7FEBDC}"/>
              </a:ext>
            </a:extLst>
          </p:cNvPr>
          <p:cNvCxnSpPr>
            <a:cxnSpLocks/>
          </p:cNvCxnSpPr>
          <p:nvPr/>
        </p:nvCxnSpPr>
        <p:spPr>
          <a:xfrm>
            <a:off x="5612483" y="2326717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0F456B47-AA9A-4796-90C0-60DCD05B608D}"/>
              </a:ext>
            </a:extLst>
          </p:cNvPr>
          <p:cNvSpPr txBox="1"/>
          <p:nvPr/>
        </p:nvSpPr>
        <p:spPr>
          <a:xfrm>
            <a:off x="5659996" y="2222241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625FF3D-FA57-44EB-8C32-5C052E4C3F98}"/>
              </a:ext>
            </a:extLst>
          </p:cNvPr>
          <p:cNvSpPr txBox="1"/>
          <p:nvPr/>
        </p:nvSpPr>
        <p:spPr>
          <a:xfrm>
            <a:off x="5659997" y="2482857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kDa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9D6F8C58-587F-4E83-BE49-24E639368A33}"/>
              </a:ext>
            </a:extLst>
          </p:cNvPr>
          <p:cNvCxnSpPr>
            <a:cxnSpLocks/>
          </p:cNvCxnSpPr>
          <p:nvPr/>
        </p:nvCxnSpPr>
        <p:spPr>
          <a:xfrm>
            <a:off x="5612483" y="2590579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55440C6D-6401-4941-8687-23348DFF95C3}"/>
              </a:ext>
            </a:extLst>
          </p:cNvPr>
          <p:cNvSpPr txBox="1"/>
          <p:nvPr/>
        </p:nvSpPr>
        <p:spPr>
          <a:xfrm>
            <a:off x="7007651" y="1432892"/>
            <a:ext cx="1243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Negative control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07F4210-08A1-487C-957E-B43D51FDC094}"/>
              </a:ext>
            </a:extLst>
          </p:cNvPr>
          <p:cNvCxnSpPr>
            <a:cxnSpLocks/>
          </p:cNvCxnSpPr>
          <p:nvPr/>
        </p:nvCxnSpPr>
        <p:spPr>
          <a:xfrm>
            <a:off x="6901767" y="1675056"/>
            <a:ext cx="14954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C97574A3-BF88-43C1-9886-F6C9293B33D7}"/>
              </a:ext>
            </a:extLst>
          </p:cNvPr>
          <p:cNvSpPr txBox="1"/>
          <p:nvPr/>
        </p:nvSpPr>
        <p:spPr>
          <a:xfrm>
            <a:off x="6826093" y="1738861"/>
            <a:ext cx="411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C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A400742-93DB-498F-90CB-0F307D2DA65F}"/>
              </a:ext>
            </a:extLst>
          </p:cNvPr>
          <p:cNvSpPr txBox="1"/>
          <p:nvPr/>
        </p:nvSpPr>
        <p:spPr>
          <a:xfrm>
            <a:off x="7083849" y="1740906"/>
            <a:ext cx="411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C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B289027-CF3E-41AC-8461-6637E717A5D4}"/>
              </a:ext>
            </a:extLst>
          </p:cNvPr>
          <p:cNvSpPr txBox="1"/>
          <p:nvPr/>
        </p:nvSpPr>
        <p:spPr>
          <a:xfrm>
            <a:off x="7355832" y="1738861"/>
            <a:ext cx="411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C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A0DCC06-FB7F-4ECC-9CBF-E4C20204BAF7}"/>
              </a:ext>
            </a:extLst>
          </p:cNvPr>
          <p:cNvSpPr txBox="1"/>
          <p:nvPr/>
        </p:nvSpPr>
        <p:spPr>
          <a:xfrm>
            <a:off x="7613588" y="1738702"/>
            <a:ext cx="411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C4</a:t>
            </a: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8160DFF4-4C43-4864-888B-CE8EB1E790A6}"/>
              </a:ext>
            </a:extLst>
          </p:cNvPr>
          <p:cNvCxnSpPr>
            <a:cxnSpLocks/>
          </p:cNvCxnSpPr>
          <p:nvPr/>
        </p:nvCxnSpPr>
        <p:spPr>
          <a:xfrm>
            <a:off x="8414560" y="2309367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2767875E-2911-465B-B842-4F49A19D4AD0}"/>
              </a:ext>
            </a:extLst>
          </p:cNvPr>
          <p:cNvSpPr txBox="1"/>
          <p:nvPr/>
        </p:nvSpPr>
        <p:spPr>
          <a:xfrm>
            <a:off x="8462073" y="2204891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390E2F7-5672-4309-AA21-B9C87154FE1D}"/>
              </a:ext>
            </a:extLst>
          </p:cNvPr>
          <p:cNvSpPr txBox="1"/>
          <p:nvPr/>
        </p:nvSpPr>
        <p:spPr>
          <a:xfrm>
            <a:off x="8462073" y="2522834"/>
            <a:ext cx="478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kDa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9A9FFEFF-7698-4BF9-A4AB-948AB0A8EAA2}"/>
              </a:ext>
            </a:extLst>
          </p:cNvPr>
          <p:cNvCxnSpPr>
            <a:cxnSpLocks/>
          </p:cNvCxnSpPr>
          <p:nvPr/>
        </p:nvCxnSpPr>
        <p:spPr>
          <a:xfrm>
            <a:off x="8414559" y="2630556"/>
            <a:ext cx="950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F98E20AC-85CB-4D87-B73D-8A840B7EA656}"/>
              </a:ext>
            </a:extLst>
          </p:cNvPr>
          <p:cNvSpPr txBox="1"/>
          <p:nvPr/>
        </p:nvSpPr>
        <p:spPr>
          <a:xfrm>
            <a:off x="6528372" y="1483541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3E74543-A444-4216-B4D0-EEA33E1A1A1D}"/>
              </a:ext>
            </a:extLst>
          </p:cNvPr>
          <p:cNvSpPr txBox="1"/>
          <p:nvPr/>
        </p:nvSpPr>
        <p:spPr>
          <a:xfrm>
            <a:off x="1319481" y="4136526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)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CA5D263-06EC-4D3E-92EF-05AF09EA120F}"/>
              </a:ext>
            </a:extLst>
          </p:cNvPr>
          <p:cNvSpPr txBox="1"/>
          <p:nvPr/>
        </p:nvSpPr>
        <p:spPr>
          <a:xfrm>
            <a:off x="5539477" y="4162089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)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C4793C2-E5BE-4D6F-8C47-7F7FC992D874}"/>
              </a:ext>
            </a:extLst>
          </p:cNvPr>
          <p:cNvSpPr txBox="1"/>
          <p:nvPr/>
        </p:nvSpPr>
        <p:spPr>
          <a:xfrm>
            <a:off x="9773793" y="4140118"/>
            <a:ext cx="369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)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5F4442A-272E-42D2-8235-78E81639CEF8}"/>
              </a:ext>
            </a:extLst>
          </p:cNvPr>
          <p:cNvSpPr txBox="1"/>
          <p:nvPr/>
        </p:nvSpPr>
        <p:spPr>
          <a:xfrm>
            <a:off x="302004" y="23489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 dirty="0"/>
              <a:t>Supplementary Figure 1</a:t>
            </a:r>
            <a:endParaRPr lang="en-US" b="1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50A4F4D-25D7-497C-991B-7781FA5AF68E}"/>
              </a:ext>
            </a:extLst>
          </p:cNvPr>
          <p:cNvSpPr txBox="1"/>
          <p:nvPr/>
        </p:nvSpPr>
        <p:spPr>
          <a:xfrm>
            <a:off x="4144253" y="4560060"/>
            <a:ext cx="452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rP</a:t>
            </a:r>
            <a:r>
              <a:rPr lang="en-US" sz="1000" baseline="30000" dirty="0"/>
              <a:t>C</a:t>
            </a:r>
            <a:endParaRPr lang="en-US" sz="1000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07BE19C-C4FA-42CB-9655-8F3479F2A999}"/>
              </a:ext>
            </a:extLst>
          </p:cNvPr>
          <p:cNvSpPr txBox="1"/>
          <p:nvPr/>
        </p:nvSpPr>
        <p:spPr>
          <a:xfrm>
            <a:off x="5247717" y="1752134"/>
            <a:ext cx="452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rP</a:t>
            </a:r>
            <a:r>
              <a:rPr lang="en-US" sz="1000" baseline="30000" dirty="0"/>
              <a:t>C</a:t>
            </a:r>
            <a:endParaRPr lang="en-US" sz="1000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3BAC9E5-996B-4DE9-8E9E-0FC5350D9382}"/>
              </a:ext>
            </a:extLst>
          </p:cNvPr>
          <p:cNvSpPr txBox="1"/>
          <p:nvPr/>
        </p:nvSpPr>
        <p:spPr>
          <a:xfrm>
            <a:off x="8057310" y="1752134"/>
            <a:ext cx="452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rP</a:t>
            </a:r>
            <a:r>
              <a:rPr lang="en-US" sz="1000" baseline="30000" dirty="0"/>
              <a:t>C</a:t>
            </a:r>
            <a:endParaRPr lang="en-US" sz="10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5A51B41-F73A-4414-B17B-3E7AB755438A}"/>
              </a:ext>
            </a:extLst>
          </p:cNvPr>
          <p:cNvSpPr txBox="1"/>
          <p:nvPr/>
        </p:nvSpPr>
        <p:spPr>
          <a:xfrm>
            <a:off x="10477750" y="4585241"/>
            <a:ext cx="452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rP</a:t>
            </a:r>
            <a:r>
              <a:rPr lang="en-US" sz="1000" baseline="30000" dirty="0"/>
              <a:t>C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986626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6</TotalTime>
  <Words>85</Words>
  <Application>Microsoft Office PowerPoint</Application>
  <PresentationFormat>Widescreen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rigo Morales</dc:creator>
  <cp:lastModifiedBy>Morales, Rodrigo</cp:lastModifiedBy>
  <cp:revision>11</cp:revision>
  <dcterms:created xsi:type="dcterms:W3CDTF">2024-11-21T23:21:27Z</dcterms:created>
  <dcterms:modified xsi:type="dcterms:W3CDTF">2025-06-11T22:35:13Z</dcterms:modified>
</cp:coreProperties>
</file>